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81854" autoAdjust="0"/>
  </p:normalViewPr>
  <p:slideViewPr>
    <p:cSldViewPr snapToGrid="0" snapToObjects="1">
      <p:cViewPr>
        <p:scale>
          <a:sx n="89" d="100"/>
          <a:sy n="89" d="100"/>
        </p:scale>
        <p:origin x="-324" y="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%20HD:Users:hoeflich:Desktop:120613%20CTG%20Combo%20G2683%20DTX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11872920417899"/>
          <c:y val="5.3841199442347297E-2"/>
          <c:w val="0.83568120941597901"/>
          <c:h val="0.791482915773254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o120613G2683DTX.xls!$C$428:$H$428</c:f>
                <c:numCache>
                  <c:formatCode>General</c:formatCode>
                  <c:ptCount val="6"/>
                  <c:pt idx="0">
                    <c:v>5848.0344276232399</c:v>
                  </c:pt>
                  <c:pt idx="1">
                    <c:v>3293.0864954730032</c:v>
                  </c:pt>
                  <c:pt idx="2">
                    <c:v>3804.27215991005</c:v>
                  </c:pt>
                  <c:pt idx="3">
                    <c:v>1084.9878647554849</c:v>
                  </c:pt>
                  <c:pt idx="4">
                    <c:v>2609.1221384468249</c:v>
                  </c:pt>
                  <c:pt idx="5">
                    <c:v>859.280464497283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/>
            </c:spPr>
          </c:errBars>
          <c:cat>
            <c:strRef>
              <c:f>co120613G2683DTX.xls!$C$426:$H$426</c:f>
              <c:strCache>
                <c:ptCount val="6"/>
                <c:pt idx="0">
                  <c:v>DMSO</c:v>
                </c:pt>
                <c:pt idx="1">
                  <c:v>2uM G2685</c:v>
                </c:pt>
                <c:pt idx="2">
                  <c:v>0.1uM DTX</c:v>
                </c:pt>
                <c:pt idx="3">
                  <c:v>G2683_DTX same time</c:v>
                </c:pt>
                <c:pt idx="4">
                  <c:v>G2683_24hrs later_DTX</c:v>
                </c:pt>
                <c:pt idx="5">
                  <c:v>DTX_24hrs later_G2683</c:v>
                </c:pt>
              </c:strCache>
            </c:strRef>
          </c:cat>
          <c:val>
            <c:numRef>
              <c:f>co120613G2683DTX.xls!$C$427:$H$427</c:f>
              <c:numCache>
                <c:formatCode>General</c:formatCode>
                <c:ptCount val="6"/>
                <c:pt idx="0">
                  <c:v>211474</c:v>
                </c:pt>
                <c:pt idx="1">
                  <c:v>95084</c:v>
                </c:pt>
                <c:pt idx="2">
                  <c:v>71621</c:v>
                </c:pt>
                <c:pt idx="3">
                  <c:v>47653</c:v>
                </c:pt>
                <c:pt idx="4">
                  <c:v>68680.5</c:v>
                </c:pt>
                <c:pt idx="5">
                  <c:v>40589.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0"/>
        <c:axId val="384243968"/>
        <c:axId val="384245760"/>
      </c:barChart>
      <c:catAx>
        <c:axId val="38424396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0" anchor="ctr" anchorCtr="1"/>
          <a:lstStyle/>
          <a:p>
            <a:pPr>
              <a:defRPr/>
            </a:pPr>
            <a:endParaRPr lang="en-US"/>
          </a:p>
        </c:txPr>
        <c:crossAx val="384245760"/>
        <c:crosses val="autoZero"/>
        <c:auto val="1"/>
        <c:lblAlgn val="ctr"/>
        <c:lblOffset val="100"/>
        <c:noMultiLvlLbl val="0"/>
      </c:catAx>
      <c:valAx>
        <c:axId val="384245760"/>
        <c:scaling>
          <c:orientation val="minMax"/>
          <c:max val="2200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/>
              </a:defRPr>
            </a:pPr>
            <a:endParaRPr lang="en-US"/>
          </a:p>
        </c:txPr>
        <c:crossAx val="384243968"/>
        <c:crosses val="autoZero"/>
        <c:crossBetween val="between"/>
      </c:valAx>
    </c:plotArea>
    <c:plotVisOnly val="1"/>
    <c:dispBlanksAs val="gap"/>
    <c:showDLblsOverMax val="0"/>
  </c:chart>
  <c:spPr>
    <a:ln w="25400"/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C97A7A-7A2E-344B-BE84-79CA7B781979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F51979-CDBD-F54A-B215-11E850204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0143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>
              <a:latin typeface="Calibri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F51979-CDBD-F54A-B215-11E85020430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8648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913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732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055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907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458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544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715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428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161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356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109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459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Group 64"/>
          <p:cNvGrpSpPr/>
          <p:nvPr/>
        </p:nvGrpSpPr>
        <p:grpSpPr>
          <a:xfrm>
            <a:off x="1751032" y="2863664"/>
            <a:ext cx="3333023" cy="2958199"/>
            <a:chOff x="2207485" y="5632688"/>
            <a:chExt cx="4141892" cy="2862136"/>
          </a:xfrm>
        </p:grpSpPr>
        <p:graphicFrame>
          <p:nvGraphicFramePr>
            <p:cNvPr id="66" name="Chart 6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75734201"/>
                </p:ext>
              </p:extLst>
            </p:nvPr>
          </p:nvGraphicFramePr>
          <p:xfrm>
            <a:off x="2398008" y="5632688"/>
            <a:ext cx="3951368" cy="24718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7" name="Rectangle 66"/>
            <p:cNvSpPr/>
            <p:nvPr/>
          </p:nvSpPr>
          <p:spPr>
            <a:xfrm>
              <a:off x="2848690" y="7669369"/>
              <a:ext cx="3500687" cy="3147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TextBox 67"/>
            <p:cNvSpPr txBox="1"/>
            <p:nvPr/>
          </p:nvSpPr>
          <p:spPr>
            <a:xfrm rot="18450225">
              <a:off x="2766982" y="7670944"/>
              <a:ext cx="607859" cy="32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 smtClean="0">
                  <a:latin typeface="Arial"/>
                  <a:cs typeface="Arial"/>
                </a:rPr>
                <a:t>DMSO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 rot="18450225">
              <a:off x="3146471" y="7786410"/>
              <a:ext cx="874696" cy="32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 smtClean="0">
                  <a:latin typeface="Arial"/>
                  <a:cs typeface="Arial"/>
                </a:rPr>
                <a:t>FRAX1036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 rot="18450225">
              <a:off x="4007674" y="7609901"/>
              <a:ext cx="466794" cy="325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 smtClean="0">
                  <a:latin typeface="Arial"/>
                  <a:cs typeface="Arial"/>
                </a:rPr>
                <a:t>DTX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 rot="18450225">
              <a:off x="4165518" y="7738970"/>
              <a:ext cx="854634" cy="5354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 smtClean="0">
                  <a:latin typeface="Arial"/>
                  <a:cs typeface="Arial"/>
                </a:rPr>
                <a:t>FRAX1036</a:t>
              </a:r>
            </a:p>
            <a:p>
              <a:pPr algn="r"/>
              <a:r>
                <a:rPr lang="en-US" sz="1100" dirty="0" smtClean="0">
                  <a:latin typeface="Arial"/>
                  <a:cs typeface="Arial"/>
                </a:rPr>
                <a:t>+ DTX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 rot="18450225">
              <a:off x="4668288" y="7770151"/>
              <a:ext cx="913888" cy="535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 smtClean="0">
                  <a:latin typeface="Arial"/>
                  <a:cs typeface="Arial"/>
                </a:rPr>
                <a:t>FRAX1036,</a:t>
              </a:r>
            </a:p>
            <a:p>
              <a:pPr algn="r"/>
              <a:r>
                <a:rPr lang="en-US" sz="1100" dirty="0" smtClean="0">
                  <a:latin typeface="Arial"/>
                  <a:cs typeface="Arial"/>
                </a:rPr>
                <a:t>then DTX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 rot="18450225">
              <a:off x="5327304" y="7772507"/>
              <a:ext cx="874696" cy="5354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 smtClean="0">
                  <a:latin typeface="Arial"/>
                  <a:cs typeface="Arial"/>
                </a:rPr>
                <a:t>DTX, then</a:t>
              </a:r>
            </a:p>
            <a:p>
              <a:pPr algn="r"/>
              <a:r>
                <a:rPr lang="en-US" sz="1100" dirty="0" smtClean="0">
                  <a:latin typeface="Arial"/>
                  <a:cs typeface="Arial"/>
                </a:rPr>
                <a:t>FRAX1036</a:t>
              </a:r>
            </a:p>
          </p:txBody>
        </p:sp>
        <p:sp>
          <p:nvSpPr>
            <p:cNvPr id="74" name="Rectangle 73"/>
            <p:cNvSpPr/>
            <p:nvPr/>
          </p:nvSpPr>
          <p:spPr>
            <a:xfrm>
              <a:off x="2369331" y="5829666"/>
              <a:ext cx="529929" cy="18155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606222" y="7451649"/>
              <a:ext cx="3803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/>
                  <a:cs typeface="Arial"/>
                </a:rPr>
                <a:t>0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609691" y="7041417"/>
              <a:ext cx="3803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/>
                  <a:cs typeface="Arial"/>
                </a:rPr>
                <a:t>5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207485" y="6631854"/>
              <a:ext cx="7825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/>
                  <a:cs typeface="Arial"/>
                </a:rPr>
                <a:t>10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461286" y="6221622"/>
              <a:ext cx="532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/>
                  <a:cs typeface="Arial"/>
                </a:rPr>
                <a:t>15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318611" y="5815526"/>
              <a:ext cx="674236" cy="223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/>
                  <a:cs typeface="Arial"/>
                </a:rPr>
                <a:t>20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 rot="16200000">
              <a:off x="1755960" y="6608391"/>
              <a:ext cx="15972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/>
                  <a:cs typeface="Arial"/>
                </a:rPr>
                <a:t>V</a:t>
              </a:r>
              <a:r>
                <a:rPr lang="en-US" sz="1200" dirty="0" smtClean="0">
                  <a:latin typeface="Arial"/>
                  <a:cs typeface="Arial"/>
                </a:rPr>
                <a:t>iability (RLU x 10</a:t>
              </a:r>
              <a:r>
                <a:rPr lang="en-US" sz="1200" baseline="30000" dirty="0" smtClean="0">
                  <a:latin typeface="Arial"/>
                  <a:cs typeface="Arial"/>
                </a:rPr>
                <a:t>5</a:t>
              </a:r>
              <a:r>
                <a:rPr lang="en-US" sz="1200" dirty="0" smtClean="0">
                  <a:latin typeface="Arial"/>
                  <a:cs typeface="Arial"/>
                </a:rPr>
                <a:t>)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sp>
        <p:nvSpPr>
          <p:cNvPr id="82" name="Title 1"/>
          <p:cNvSpPr txBox="1">
            <a:spLocks/>
          </p:cNvSpPr>
          <p:nvPr/>
        </p:nvSpPr>
        <p:spPr>
          <a:xfrm>
            <a:off x="52174" y="103934"/>
            <a:ext cx="2352291" cy="3194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 err="1" smtClean="0">
                <a:latin typeface="Arial" charset="0"/>
                <a:cs typeface="Arial" charset="0"/>
              </a:rPr>
              <a:t>Suppl</a:t>
            </a:r>
            <a:r>
              <a:rPr lang="en-US" sz="2000" b="1" dirty="0" smtClean="0">
                <a:latin typeface="Arial" charset="0"/>
                <a:cs typeface="Arial" charset="0"/>
              </a:rPr>
              <a:t> Figure 6</a:t>
            </a:r>
            <a:endParaRPr lang="en-US" sz="2000" dirty="0">
              <a:latin typeface="Arial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412645" y="3528911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>
            <a:off x="2908037" y="3852345"/>
            <a:ext cx="639573" cy="0"/>
          </a:xfrm>
          <a:prstGeom prst="line">
            <a:avLst/>
          </a:prstGeom>
          <a:ln w="1270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V="1">
            <a:off x="3859467" y="3697371"/>
            <a:ext cx="0" cy="606328"/>
          </a:xfrm>
          <a:prstGeom prst="line">
            <a:avLst/>
          </a:prstGeom>
          <a:ln w="1270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H="1">
            <a:off x="3237552" y="3700929"/>
            <a:ext cx="621915" cy="0"/>
          </a:xfrm>
          <a:prstGeom prst="line">
            <a:avLst/>
          </a:prstGeom>
          <a:ln w="1270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V="1">
            <a:off x="3229363" y="3697371"/>
            <a:ext cx="1381" cy="155522"/>
          </a:xfrm>
          <a:prstGeom prst="line">
            <a:avLst/>
          </a:prstGeom>
          <a:ln w="1270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4371865" y="3869356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Straight Connector 37"/>
          <p:cNvCxnSpPr/>
          <p:nvPr/>
        </p:nvCxnSpPr>
        <p:spPr>
          <a:xfrm flipV="1">
            <a:off x="4711111" y="4037745"/>
            <a:ext cx="0" cy="379934"/>
          </a:xfrm>
          <a:prstGeom prst="line">
            <a:avLst/>
          </a:prstGeom>
          <a:ln w="1270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H="1">
            <a:off x="4296665" y="4041374"/>
            <a:ext cx="414446" cy="0"/>
          </a:xfrm>
          <a:prstGeom prst="line">
            <a:avLst/>
          </a:prstGeom>
          <a:ln w="1270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V="1">
            <a:off x="4288475" y="4034187"/>
            <a:ext cx="1381" cy="155522"/>
          </a:xfrm>
          <a:prstGeom prst="line">
            <a:avLst/>
          </a:prstGeom>
          <a:ln w="1270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405299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07</TotalTime>
  <Words>31</Words>
  <Application>Microsoft Office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nstall</dc:creator>
  <cp:lastModifiedBy>Joachim Rudolph</cp:lastModifiedBy>
  <cp:revision>169</cp:revision>
  <cp:lastPrinted>2015-01-13T20:11:25Z</cp:lastPrinted>
  <dcterms:created xsi:type="dcterms:W3CDTF">2014-04-13T22:32:15Z</dcterms:created>
  <dcterms:modified xsi:type="dcterms:W3CDTF">2015-01-19T07:41:20Z</dcterms:modified>
</cp:coreProperties>
</file>